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7099300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2C3E32-17D3-4AA9-AA33-184DC4DA570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C268AF-0D69-4741-B2F4-D945EF49AA5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AF0D1D-5FBB-4FDB-A569-EC71D4CD753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802822-A03E-4BA8-8CD1-681C55E3337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FFD146-C038-47FE-A645-DB9C7BE38AB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AC9D3C-7A8B-498D-8F1C-3BE50ABDA1C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5956E7-716E-4F98-9F13-7E353CE35CC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ECE4C9-9957-484A-91B6-64ED033465D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B4C7E3-17DB-445A-93E5-7169263F676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D42817-0834-484A-AAEE-481697C171C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12809E-E270-433C-A7A3-237ACDE8A25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C0009A-21F9-4E68-9FDC-FB271557165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0E4A866-E1E8-4F3F-A336-9148F5AAE419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rcRect l="0" t="0" r="42093" b="0"/>
          <a:stretch/>
        </p:blipFill>
        <p:spPr>
          <a:xfrm>
            <a:off x="620640" y="2382840"/>
            <a:ext cx="3189240" cy="223848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 rot="16200000">
            <a:off x="2204280" y="1644120"/>
            <a:ext cx="1233360" cy="282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100" spc="-1" strike="noStrike">
                <a:solidFill>
                  <a:srgbClr val="000000"/>
                </a:solidFill>
                <a:latin typeface="Arial"/>
              </a:rPr>
              <a:t>WT</a:t>
            </a:r>
            <a:r>
              <a:rPr b="1" lang="de-DE" sz="1100" spc="-1" strike="noStrike" baseline="-25000">
                <a:solidFill>
                  <a:srgbClr val="000000"/>
                </a:solidFill>
                <a:latin typeface="Arial"/>
              </a:rPr>
              <a:t>hyp</a:t>
            </a:r>
            <a:r>
              <a:rPr b="1" lang="de-DE" sz="1100" spc="-1" strike="noStrike">
                <a:solidFill>
                  <a:srgbClr val="000000"/>
                </a:solidFill>
                <a:latin typeface="Arial"/>
              </a:rPr>
              <a:t>/</a:t>
            </a:r>
            <a:r>
              <a:rPr b="1" lang="de-DE" sz="1100" spc="-1" strike="noStrike" baseline="-25000">
                <a:solidFill>
                  <a:srgbClr val="000000"/>
                </a:solidFill>
                <a:latin typeface="Arial"/>
              </a:rPr>
              <a:t>normox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 rot="16200000">
            <a:off x="922320" y="1614600"/>
            <a:ext cx="1326960" cy="282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AtHb1/WT</a:t>
            </a:r>
            <a:r>
              <a:rPr b="1" lang="en-US" sz="1100" spc="-1" strike="noStrike" baseline="-25000">
                <a:solidFill>
                  <a:srgbClr val="000000"/>
                </a:solidFill>
                <a:latin typeface="Arial"/>
              </a:rPr>
              <a:t>hyp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 rot="16200000">
            <a:off x="326520" y="1617480"/>
            <a:ext cx="1289160" cy="25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5160" rIns="65160" tIns="32760" bIns="3276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AtHb1/WT</a:t>
            </a:r>
            <a:r>
              <a:rPr b="1" lang="en-US" sz="1100" spc="-1" strike="noStrike" baseline="-25000">
                <a:solidFill>
                  <a:srgbClr val="000000"/>
                </a:solidFill>
                <a:latin typeface="Arial"/>
              </a:rPr>
              <a:t>normox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 rot="16200000">
            <a:off x="2705400" y="1560960"/>
            <a:ext cx="1465560" cy="282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AtHb1</a:t>
            </a:r>
            <a:r>
              <a:rPr b="1" lang="en-US" sz="1100" spc="-1" strike="noStrike" baseline="-25000">
                <a:solidFill>
                  <a:srgbClr val="000000"/>
                </a:solidFill>
                <a:latin typeface="Arial"/>
              </a:rPr>
              <a:t>hyp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/</a:t>
            </a:r>
            <a:r>
              <a:rPr b="1" lang="en-US" sz="1100" spc="-1" strike="noStrike" baseline="-25000">
                <a:solidFill>
                  <a:srgbClr val="000000"/>
                </a:solidFill>
                <a:latin typeface="Arial"/>
              </a:rPr>
              <a:t>normox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3038400" y="4316400"/>
            <a:ext cx="1749600" cy="341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5160" rIns="65160" tIns="32760" bIns="3276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7" name=""/>
          <p:cNvGraphicFramePr/>
          <p:nvPr/>
        </p:nvGraphicFramePr>
        <p:xfrm>
          <a:off x="3759120" y="2335320"/>
          <a:ext cx="3240000" cy="2163600"/>
        </p:xfrm>
        <a:graphic>
          <a:graphicData uri="http://schemas.openxmlformats.org/drawingml/2006/table">
            <a:tbl>
              <a:tblPr/>
              <a:tblGrid>
                <a:gridCol w="3240000"/>
              </a:tblGrid>
              <a:tr h="218520">
                <a:tc>
                  <a:txBody>
                    <a:bodyPr lIns="65160" rIns="65160" tIns="32760" bIns="32760" anchor="b">
                      <a:noAutofit/>
                    </a:bodyPr>
                    <a:p>
                      <a:pPr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zinc finger (C3HC4-type RING finger) family protei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5160" marR="65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9760">
                <a:tc>
                  <a:txBody>
                    <a:bodyPr lIns="65160" rIns="65160" tIns="32760" bIns="32760" anchor="b">
                      <a:noAutofit/>
                    </a:bodyPr>
                    <a:p>
                      <a:pPr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zinc finger (C3HC4-type RING finger) family protei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5160" marR="65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9400">
                <a:tc>
                  <a:txBody>
                    <a:bodyPr lIns="65160" rIns="65160" tIns="32760" bIns="32760" anchor="b">
                      <a:noAutofit/>
                    </a:bodyPr>
                    <a:p>
                      <a:pPr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zinc finger (C3HC4-type RING finger) family protei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5160" marR="65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9760">
                <a:tc>
                  <a:txBody>
                    <a:bodyPr lIns="65160" rIns="65160" tIns="32760" bIns="32760" anchor="b">
                      <a:noAutofit/>
                    </a:bodyPr>
                    <a:p>
                      <a:pPr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zinc finger (C3HC4-type RING finger) family protei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5160" marR="65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9400">
                <a:tc>
                  <a:txBody>
                    <a:bodyPr lIns="65160" rIns="65160" tIns="32760" bIns="32760" anchor="b">
                      <a:noAutofit/>
                    </a:bodyPr>
                    <a:p>
                      <a:pPr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utative DNA-binding protei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5160" marR="65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9760">
                <a:tc>
                  <a:txBody>
                    <a:bodyPr lIns="65160" rIns="65160" tIns="32760" bIns="32760" anchor="b">
                      <a:noAutofit/>
                    </a:bodyPr>
                    <a:p>
                      <a:pPr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U-box domain-containing protei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5160" marR="65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9760">
                <a:tc>
                  <a:txBody>
                    <a:bodyPr lIns="65160" rIns="65160" tIns="32760" bIns="32760" anchor="b">
                      <a:noAutofit/>
                    </a:bodyPr>
                    <a:p>
                      <a:pPr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U-box domain-containing protei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5160" marR="65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9760">
                <a:tc>
                  <a:txBody>
                    <a:bodyPr lIns="65160" rIns="65160" tIns="32760" bIns="32760" anchor="b">
                      <a:noAutofit/>
                    </a:bodyPr>
                    <a:p>
                      <a:pPr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ING-H2 finger protein RHA3b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5160" marR="65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9400">
                <a:tc>
                  <a:txBody>
                    <a:bodyPr lIns="65160" rIns="65160" tIns="32760" bIns="32760" anchor="b">
                      <a:noAutofit/>
                    </a:bodyPr>
                    <a:p>
                      <a:pPr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ING-H2 finger protein RHA2b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5160" marR="65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9760">
                <a:tc>
                  <a:txBody>
                    <a:bodyPr lIns="65160" rIns="65160" tIns="32760" bIns="32760" anchor="b">
                      <a:noAutofit/>
                    </a:bodyPr>
                    <a:p>
                      <a:pPr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zinc finger (C3HC4-type RING finger) family protei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5160" marR="65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9400">
                <a:tc>
                  <a:txBody>
                    <a:bodyPr lIns="65160" rIns="65160" tIns="32760" bIns="32760" anchor="b">
                      <a:noAutofit/>
                    </a:bodyPr>
                    <a:p>
                      <a:pPr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zinc finger (C3HC4-type RING finger) family protei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5160" marR="65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9760">
                <a:tc>
                  <a:txBody>
                    <a:bodyPr lIns="65160" rIns="65160" tIns="32760" bIns="32760" anchor="b">
                      <a:noAutofit/>
                    </a:bodyPr>
                    <a:p>
                      <a:pPr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KP1/ASK1-relate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5160" marR="65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9400">
                <a:tc>
                  <a:txBody>
                    <a:bodyPr lIns="65160" rIns="65160" tIns="32760" bIns="32760" anchor="b">
                      <a:noAutofit/>
                    </a:bodyPr>
                    <a:p>
                      <a:pPr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kelch repeat-containing F-box family protei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5160" marR="65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9760">
                <a:tc>
                  <a:txBody>
                    <a:bodyPr lIns="65160" rIns="65160" tIns="32760" bIns="32760" anchor="b">
                      <a:noAutofit/>
                    </a:bodyPr>
                    <a:p>
                      <a:pPr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F-box family protei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5160" marR="65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grpSp>
        <p:nvGrpSpPr>
          <p:cNvPr id="48" name=""/>
          <p:cNvGrpSpPr/>
          <p:nvPr/>
        </p:nvGrpSpPr>
        <p:grpSpPr>
          <a:xfrm>
            <a:off x="4587840" y="1649520"/>
            <a:ext cx="1331640" cy="634680"/>
            <a:chOff x="4587840" y="1649520"/>
            <a:chExt cx="1331640" cy="634680"/>
          </a:xfrm>
        </p:grpSpPr>
        <p:pic>
          <p:nvPicPr>
            <p:cNvPr id="49" name="" descr=""/>
            <p:cNvPicPr/>
            <p:nvPr/>
          </p:nvPicPr>
          <p:blipFill>
            <a:blip r:embed="rId2"/>
            <a:stretch/>
          </p:blipFill>
          <p:spPr>
            <a:xfrm>
              <a:off x="4587840" y="1649520"/>
              <a:ext cx="1321920" cy="279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0" name=""/>
            <p:cNvSpPr/>
            <p:nvPr/>
          </p:nvSpPr>
          <p:spPr>
            <a:xfrm>
              <a:off x="4621320" y="1824120"/>
              <a:ext cx="1298160" cy="460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spAutoFit/>
            </a:bodyPr>
            <a:p>
              <a:pPr>
                <a:lnSpc>
                  <a:spcPct val="85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1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r>
                <a:rPr b="1" lang="de-DE" sz="1000" spc="-1" strike="noStrike">
                  <a:solidFill>
                    <a:srgbClr val="000000"/>
                  </a:solidFill>
                  <a:latin typeface="Arial"/>
                </a:rPr>
                <a:t>1.5      0.0      1.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85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000000"/>
                  </a:solidFill>
                  <a:latin typeface="Arial"/>
                </a:rPr>
                <a:t>Signal log</a:t>
              </a:r>
              <a:r>
                <a:rPr b="1" lang="de-DE" sz="1000" spc="-1" strike="noStrike" baseline="-25000">
                  <a:solidFill>
                    <a:srgbClr val="000000"/>
                  </a:solidFill>
                  <a:latin typeface="Arial"/>
                </a:rPr>
                <a:t>2</a:t>
              </a:r>
              <a:r>
                <a:rPr b="1" lang="de-DE" sz="1000" spc="-1" strike="noStrike">
                  <a:solidFill>
                    <a:srgbClr val="000000"/>
                  </a:solidFill>
                  <a:latin typeface="Arial"/>
                </a:rPr>
                <a:t> ratio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7-17T15:52:47Z</dcterms:created>
  <dc:creator>ITB</dc:creator>
  <dc:description/>
  <dc:language>en-US</dc:language>
  <cp:lastModifiedBy>rollet</cp:lastModifiedBy>
  <dcterms:modified xsi:type="dcterms:W3CDTF">2011-03-01T13:43:12Z</dcterms:modified>
  <cp:revision>5</cp:revision>
  <dc:subject/>
  <dc:title>Folie 1</dc:title>
</cp:coreProperties>
</file>